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9" r:id="rId3"/>
    <p:sldId id="275" r:id="rId4"/>
    <p:sldId id="264" r:id="rId5"/>
    <p:sldId id="270" r:id="rId6"/>
    <p:sldId id="276" r:id="rId7"/>
    <p:sldId id="265" r:id="rId8"/>
    <p:sldId id="271" r:id="rId9"/>
    <p:sldId id="277" r:id="rId10"/>
    <p:sldId id="266" r:id="rId11"/>
    <p:sldId id="272" r:id="rId12"/>
    <p:sldId id="278" r:id="rId13"/>
    <p:sldId id="267" r:id="rId14"/>
    <p:sldId id="273" r:id="rId15"/>
    <p:sldId id="279" r:id="rId16"/>
    <p:sldId id="268" r:id="rId17"/>
    <p:sldId id="274" r:id="rId18"/>
    <p:sldId id="280" r:id="rId1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867" autoAdjust="0"/>
    <p:restoredTop sz="94660"/>
  </p:normalViewPr>
  <p:slideViewPr>
    <p:cSldViewPr>
      <p:cViewPr>
        <p:scale>
          <a:sx n="100" d="100"/>
          <a:sy n="100" d="100"/>
        </p:scale>
        <p:origin x="-2106" y="-2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5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95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7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57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376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187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999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352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256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735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058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E3EFD-4FB3-49AE-A123-4F8992CA270E}" type="datetimeFigureOut">
              <a:rPr lang="en-US" smtClean="0"/>
              <a:t>11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622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1" t="8261" r="1327" b="2942"/>
          <a:stretch/>
        </p:blipFill>
        <p:spPr bwMode="auto">
          <a:xfrm>
            <a:off x="1219200" y="914399"/>
            <a:ext cx="6629400" cy="2438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8" t="11111" r="1888" b="2778"/>
          <a:stretch/>
        </p:blipFill>
        <p:spPr bwMode="auto">
          <a:xfrm>
            <a:off x="1257300" y="3809999"/>
            <a:ext cx="6553201" cy="2362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901405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" t="10996" r="1221" b="3319"/>
          <a:stretch/>
        </p:blipFill>
        <p:spPr bwMode="auto">
          <a:xfrm>
            <a:off x="1247775" y="990599"/>
            <a:ext cx="6638926" cy="2350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0" t="11111" r="1599" b="3203"/>
          <a:stretch/>
        </p:blipFill>
        <p:spPr bwMode="auto">
          <a:xfrm>
            <a:off x="1263127" y="3886200"/>
            <a:ext cx="6608223" cy="2350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55928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</a:p>
        </p:txBody>
      </p:sp>
      <p:pic>
        <p:nvPicPr>
          <p:cNvPr id="1536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" t="8333" r="1538" b="2778"/>
          <a:stretch/>
        </p:blipFill>
        <p:spPr bwMode="auto">
          <a:xfrm>
            <a:off x="1406900" y="1066800"/>
            <a:ext cx="6629401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63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5" t="10383" r="1605" b="3200"/>
          <a:stretch/>
        </p:blipFill>
        <p:spPr bwMode="auto">
          <a:xfrm>
            <a:off x="1371600" y="4191000"/>
            <a:ext cx="6700000" cy="24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17954" y="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8" t="11536" r="1539" b="2746"/>
          <a:stretch/>
        </p:blipFill>
        <p:spPr bwMode="auto">
          <a:xfrm>
            <a:off x="1219200" y="1002268"/>
            <a:ext cx="6629400" cy="2351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9" t="8825" r="1329" b="2744"/>
          <a:stretch/>
        </p:blipFill>
        <p:spPr bwMode="auto">
          <a:xfrm>
            <a:off x="1219200" y="3746375"/>
            <a:ext cx="6629400" cy="2425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673216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KVLEYVIKV</a:t>
            </a: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3" t="16879" r="2092" b="3780"/>
          <a:stretch/>
        </p:blipFill>
        <p:spPr bwMode="auto">
          <a:xfrm>
            <a:off x="1238407" y="1100142"/>
            <a:ext cx="6553200" cy="21764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6" t="11110" r="1888" b="2778"/>
          <a:stretch/>
        </p:blipFill>
        <p:spPr bwMode="auto">
          <a:xfrm>
            <a:off x="1238407" y="3886200"/>
            <a:ext cx="6553200" cy="2362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559283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KVLEYVIKV</a:t>
            </a:r>
          </a:p>
        </p:txBody>
      </p:sp>
      <p:pic>
        <p:nvPicPr>
          <p:cNvPr id="1638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0" t="11111" r="1888" b="2778"/>
          <a:stretch/>
        </p:blipFill>
        <p:spPr bwMode="auto">
          <a:xfrm>
            <a:off x="1295400" y="914400"/>
            <a:ext cx="6553200" cy="2362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8" t="10996" r="1888" b="2893"/>
          <a:stretch/>
        </p:blipFill>
        <p:spPr bwMode="auto">
          <a:xfrm>
            <a:off x="1295400" y="3733799"/>
            <a:ext cx="6553200" cy="23622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17954" y="0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KVLEYVIKV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3" t="10481" r="1538" b="3838"/>
          <a:stretch/>
        </p:blipFill>
        <p:spPr bwMode="auto">
          <a:xfrm>
            <a:off x="1181414" y="1081767"/>
            <a:ext cx="6590987" cy="23504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9" t="10995" r="1539" b="3324"/>
          <a:stretch/>
        </p:blipFill>
        <p:spPr bwMode="auto">
          <a:xfrm>
            <a:off x="1185042" y="3883024"/>
            <a:ext cx="6583730" cy="23504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92037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SSILSTL</a:t>
            </a:r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2" t="8759" r="1539" b="2777"/>
          <a:stretch/>
        </p:blipFill>
        <p:spPr bwMode="auto">
          <a:xfrm>
            <a:off x="1164218" y="1002268"/>
            <a:ext cx="6586964" cy="2426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" t="10450" r="1538" b="3439"/>
          <a:stretch/>
        </p:blipFill>
        <p:spPr bwMode="auto">
          <a:xfrm>
            <a:off x="1143000" y="3809999"/>
            <a:ext cx="6629401" cy="23622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1612245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SSILSTL</a:t>
            </a:r>
          </a:p>
        </p:txBody>
      </p:sp>
      <p:pic>
        <p:nvPicPr>
          <p:cNvPr id="1741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4" t="9144" r="1539" b="4745"/>
          <a:stretch/>
        </p:blipFill>
        <p:spPr bwMode="auto">
          <a:xfrm>
            <a:off x="1397818" y="914399"/>
            <a:ext cx="6603182" cy="23622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41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4" t="11111" r="1539" b="2778"/>
          <a:stretch/>
        </p:blipFill>
        <p:spPr bwMode="auto">
          <a:xfrm>
            <a:off x="1397818" y="3962400"/>
            <a:ext cx="6603182" cy="23622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17954" y="0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SSILSTL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4" t="8262" r="1539" b="3699"/>
          <a:stretch/>
        </p:blipFill>
        <p:spPr bwMode="auto">
          <a:xfrm>
            <a:off x="1397819" y="1002267"/>
            <a:ext cx="6603182" cy="24150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3" t="8333" r="1539" b="3628"/>
          <a:stretch/>
        </p:blipFill>
        <p:spPr bwMode="auto">
          <a:xfrm>
            <a:off x="1450206" y="3886200"/>
            <a:ext cx="6498409" cy="24150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2282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" t="11421" r="1537" b="2894"/>
          <a:stretch/>
        </p:blipFill>
        <p:spPr bwMode="auto">
          <a:xfrm>
            <a:off x="1165859" y="1002267"/>
            <a:ext cx="6606541" cy="2350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9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5" t="8218" r="1538" b="2893"/>
          <a:stretch/>
        </p:blipFill>
        <p:spPr bwMode="auto">
          <a:xfrm>
            <a:off x="1165859" y="3657600"/>
            <a:ext cx="6606541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63870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2" t="10846" r="1539" b="3042"/>
          <a:stretch/>
        </p:blipFill>
        <p:spPr bwMode="auto">
          <a:xfrm>
            <a:off x="1185437" y="914400"/>
            <a:ext cx="6586964" cy="2362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5" t="11111" r="1577" b="2778"/>
          <a:stretch/>
        </p:blipFill>
        <p:spPr bwMode="auto">
          <a:xfrm>
            <a:off x="1219200" y="3962400"/>
            <a:ext cx="6586964" cy="2362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</p:spTree>
    <p:extLst>
      <p:ext uri="{BB962C8B-B14F-4D97-AF65-F5344CB8AC3E}">
        <p14:creationId xmlns:p14="http://schemas.microsoft.com/office/powerpoint/2010/main" val="40554199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>
                <a:latin typeface="Arial" panose="020B0604020202020204" pitchFamily="34" charset="0"/>
                <a:cs typeface="Arial" panose="020B0604020202020204" pitchFamily="34" charset="0"/>
              </a:rPr>
              <a:t>Replicate 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565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QGRVMTI</a:t>
            </a: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1" t="9391" r="1404" b="4923"/>
          <a:stretch/>
        </p:blipFill>
        <p:spPr bwMode="auto">
          <a:xfrm>
            <a:off x="1312923" y="1143000"/>
            <a:ext cx="6611878" cy="23505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0" t="8333" r="1403" b="2778"/>
          <a:stretch/>
        </p:blipFill>
        <p:spPr bwMode="auto">
          <a:xfrm>
            <a:off x="1312923" y="3962400"/>
            <a:ext cx="6611878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55928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565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QGRVMTI</a:t>
            </a:r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6" t="11421" r="1501" b="2894"/>
          <a:stretch/>
        </p:blipFill>
        <p:spPr bwMode="auto">
          <a:xfrm>
            <a:off x="1066801" y="1002267"/>
            <a:ext cx="6629400" cy="2350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1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" t="8218" r="1554" b="2894"/>
          <a:stretch/>
        </p:blipFill>
        <p:spPr bwMode="auto">
          <a:xfrm>
            <a:off x="1066801" y="3657599"/>
            <a:ext cx="6629400" cy="2438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17954" y="0"/>
            <a:ext cx="1565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QGRVMTI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7" t="11392" r="1221" b="2923"/>
          <a:stretch/>
        </p:blipFill>
        <p:spPr bwMode="auto">
          <a:xfrm>
            <a:off x="1219201" y="990599"/>
            <a:ext cx="6629400" cy="2350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7" t="8333" r="1221" b="2778"/>
          <a:stretch/>
        </p:blipFill>
        <p:spPr bwMode="auto">
          <a:xfrm>
            <a:off x="1219201" y="3810000"/>
            <a:ext cx="6629400" cy="243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388449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RPSGPGPEL</a:t>
            </a: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2" t="9777" r="2285" b="2777"/>
          <a:stretch/>
        </p:blipFill>
        <p:spPr bwMode="auto">
          <a:xfrm>
            <a:off x="1257300" y="877786"/>
            <a:ext cx="6553200" cy="23988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2" t="10204" r="1167" b="3687"/>
          <a:stretch/>
        </p:blipFill>
        <p:spPr bwMode="auto">
          <a:xfrm>
            <a:off x="1219200" y="3733800"/>
            <a:ext cx="6629400" cy="2362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5592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RPSGPGPEL</a:t>
            </a:r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" t="11421" r="1538" b="2894"/>
          <a:stretch/>
        </p:blipFill>
        <p:spPr bwMode="auto">
          <a:xfrm>
            <a:off x="1371600" y="1002267"/>
            <a:ext cx="6629400" cy="2350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33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" t="10908" r="1538" b="3406"/>
          <a:stretch/>
        </p:blipFill>
        <p:spPr bwMode="auto">
          <a:xfrm>
            <a:off x="1371600" y="3745467"/>
            <a:ext cx="6629400" cy="23505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659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50800" y="39624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17954" y="0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RPSGPGPEL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2" t="8218" r="1795" b="2894"/>
          <a:stretch/>
        </p:blipFill>
        <p:spPr bwMode="auto">
          <a:xfrm>
            <a:off x="1447800" y="914399"/>
            <a:ext cx="6553200" cy="2438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0" t="9937" r="1795" b="3951"/>
          <a:stretch/>
        </p:blipFill>
        <p:spPr bwMode="auto">
          <a:xfrm>
            <a:off x="1447800" y="3733800"/>
            <a:ext cx="6553200" cy="2362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94388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Bildschirmpräsentation (4:3)</PresentationFormat>
  <Paragraphs>72</Paragraphs>
  <Slides>18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8</vt:i4>
      </vt:variant>
    </vt:vector>
  </HeadingPairs>
  <TitlesOfParts>
    <vt:vector size="19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count Aktualisierung PDB</dc:creator>
  <cp:lastModifiedBy>Michael Gosh</cp:lastModifiedBy>
  <cp:revision>12</cp:revision>
  <dcterms:created xsi:type="dcterms:W3CDTF">2018-02-20T08:49:21Z</dcterms:created>
  <dcterms:modified xsi:type="dcterms:W3CDTF">2018-11-30T16:13:28Z</dcterms:modified>
</cp:coreProperties>
</file>